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2"/>
  </p:notesMasterIdLst>
  <p:sldIdLst>
    <p:sldId id="265" r:id="rId2"/>
    <p:sldId id="285" r:id="rId3"/>
    <p:sldId id="260" r:id="rId4"/>
    <p:sldId id="284" r:id="rId5"/>
    <p:sldId id="289" r:id="rId6"/>
    <p:sldId id="286" r:id="rId7"/>
    <p:sldId id="279" r:id="rId8"/>
    <p:sldId id="280" r:id="rId9"/>
    <p:sldId id="287" r:id="rId10"/>
    <p:sldId id="288" r:id="rId11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0D6D7DB2-FCAD-48A4-B902-369DCC81C7B7}">
          <p14:sldIdLst>
            <p14:sldId id="265"/>
            <p14:sldId id="285"/>
            <p14:sldId id="260"/>
            <p14:sldId id="284"/>
            <p14:sldId id="289"/>
            <p14:sldId id="286"/>
            <p14:sldId id="279"/>
            <p14:sldId id="280"/>
            <p14:sldId id="287"/>
            <p14:sldId id="288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529BE2B2-3467-4934-6E27-97761A24EC54}" name="Kate Mathers" initials="KM" userId="S::gykm6@lunet.lboro.ac.uk::4d07b8d5-1443-4e4a-88c9-95afa2dd68c5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307" autoAdjust="0"/>
    <p:restoredTop sz="94660"/>
  </p:normalViewPr>
  <p:slideViewPr>
    <p:cSldViewPr snapToGrid="0">
      <p:cViewPr varScale="1">
        <p:scale>
          <a:sx n="86" d="100"/>
          <a:sy n="86" d="100"/>
        </p:scale>
        <p:origin x="337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microsoft.com/office/2018/10/relationships/authors" Target="authors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93A040-37A5-4A23-BE5E-E31280776468}" type="datetimeFigureOut">
              <a:rPr lang="en-GB" smtClean="0"/>
              <a:t>30/04/2024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333DCA3-6BCE-4A15-BE81-CB13F9168D60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2311838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5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75" indent="0" algn="ctr">
              <a:buNone/>
              <a:defRPr sz="1500"/>
            </a:lvl2pPr>
            <a:lvl3pPr marL="685749" indent="0" algn="ctr">
              <a:buNone/>
              <a:defRPr sz="1351"/>
            </a:lvl3pPr>
            <a:lvl4pPr marL="1028622" indent="0" algn="ctr">
              <a:buNone/>
              <a:defRPr sz="1200"/>
            </a:lvl4pPr>
            <a:lvl5pPr marL="1371498" indent="0" algn="ctr">
              <a:buNone/>
              <a:defRPr sz="1200"/>
            </a:lvl5pPr>
            <a:lvl6pPr marL="1714373" indent="0" algn="ctr">
              <a:buNone/>
              <a:defRPr sz="1200"/>
            </a:lvl6pPr>
            <a:lvl7pPr marL="2057246" indent="0" algn="ctr">
              <a:buNone/>
              <a:defRPr sz="1200"/>
            </a:lvl7pPr>
            <a:lvl8pPr marL="2400120" indent="0" algn="ctr">
              <a:buNone/>
              <a:defRPr sz="1200"/>
            </a:lvl8pPr>
            <a:lvl9pPr marL="2742995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AA2CF-4442-4203-9250-C82848ABF354}" type="datetimeFigureOut">
              <a:rPr lang="en-GB" smtClean="0"/>
              <a:t>30/04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02AFB-D7A3-4CD5-9E4B-8229CC00D0F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954313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AA2CF-4442-4203-9250-C82848ABF354}" type="datetimeFigureOut">
              <a:rPr lang="en-GB" smtClean="0"/>
              <a:t>30/04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02AFB-D7A3-4CD5-9E4B-8229CC00D0F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112372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486836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9" y="486836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AA2CF-4442-4203-9250-C82848ABF354}" type="datetimeFigureOut">
              <a:rPr lang="en-GB" smtClean="0"/>
              <a:t>30/04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02AFB-D7A3-4CD5-9E4B-8229CC00D0F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703270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AA2CF-4442-4203-9250-C82848ABF354}" type="datetimeFigureOut">
              <a:rPr lang="en-GB" smtClean="0"/>
              <a:t>30/04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02AFB-D7A3-4CD5-9E4B-8229CC00D0F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4402720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279657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119290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75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49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2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49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37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24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12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299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AA2CF-4442-4203-9250-C82848ABF354}" type="datetimeFigureOut">
              <a:rPr lang="en-GB" smtClean="0"/>
              <a:t>30/04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02AFB-D7A3-4CD5-9E4B-8229CC00D0F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534265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AA2CF-4442-4203-9250-C82848ABF354}" type="datetimeFigureOut">
              <a:rPr lang="en-GB" smtClean="0"/>
              <a:t>30/04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02AFB-D7A3-4CD5-9E4B-8229CC00D0F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131175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486840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2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5" indent="0">
              <a:buNone/>
              <a:defRPr sz="1500" b="1"/>
            </a:lvl2pPr>
            <a:lvl3pPr marL="685749" indent="0">
              <a:buNone/>
              <a:defRPr sz="1351" b="1"/>
            </a:lvl3pPr>
            <a:lvl4pPr marL="1028622" indent="0">
              <a:buNone/>
              <a:defRPr sz="1200" b="1"/>
            </a:lvl4pPr>
            <a:lvl5pPr marL="1371498" indent="0">
              <a:buNone/>
              <a:defRPr sz="1200" b="1"/>
            </a:lvl5pPr>
            <a:lvl6pPr marL="1714373" indent="0">
              <a:buNone/>
              <a:defRPr sz="1200" b="1"/>
            </a:lvl6pPr>
            <a:lvl7pPr marL="2057246" indent="0">
              <a:buNone/>
              <a:defRPr sz="1200" b="1"/>
            </a:lvl7pPr>
            <a:lvl8pPr marL="2400120" indent="0">
              <a:buNone/>
              <a:defRPr sz="1200" b="1"/>
            </a:lvl8pPr>
            <a:lvl9pPr marL="274299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6" y="2241552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5" indent="0">
              <a:buNone/>
              <a:defRPr sz="1500" b="1"/>
            </a:lvl2pPr>
            <a:lvl3pPr marL="685749" indent="0">
              <a:buNone/>
              <a:defRPr sz="1351" b="1"/>
            </a:lvl3pPr>
            <a:lvl4pPr marL="1028622" indent="0">
              <a:buNone/>
              <a:defRPr sz="1200" b="1"/>
            </a:lvl4pPr>
            <a:lvl5pPr marL="1371498" indent="0">
              <a:buNone/>
              <a:defRPr sz="1200" b="1"/>
            </a:lvl5pPr>
            <a:lvl6pPr marL="1714373" indent="0">
              <a:buNone/>
              <a:defRPr sz="1200" b="1"/>
            </a:lvl6pPr>
            <a:lvl7pPr marL="2057246" indent="0">
              <a:buNone/>
              <a:defRPr sz="1200" b="1"/>
            </a:lvl7pPr>
            <a:lvl8pPr marL="2400120" indent="0">
              <a:buNone/>
              <a:defRPr sz="1200" b="1"/>
            </a:lvl8pPr>
            <a:lvl9pPr marL="274299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6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AA2CF-4442-4203-9250-C82848ABF354}" type="datetimeFigureOut">
              <a:rPr lang="en-GB" smtClean="0"/>
              <a:t>30/04/2024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02AFB-D7A3-4CD5-9E4B-8229CC00D0F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1555840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AA2CF-4442-4203-9250-C82848ABF354}" type="datetimeFigureOut">
              <a:rPr lang="en-GB" smtClean="0"/>
              <a:t>30/04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02AFB-D7A3-4CD5-9E4B-8229CC00D0F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1021418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AA2CF-4442-4203-9250-C82848ABF354}" type="datetimeFigureOut">
              <a:rPr lang="en-GB" smtClean="0"/>
              <a:t>30/04/2024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02AFB-D7A3-4CD5-9E4B-8229CC00D0F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481285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6" y="1316573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75" indent="0">
              <a:buNone/>
              <a:defRPr sz="1051"/>
            </a:lvl2pPr>
            <a:lvl3pPr marL="685749" indent="0">
              <a:buNone/>
              <a:defRPr sz="900"/>
            </a:lvl3pPr>
            <a:lvl4pPr marL="1028622" indent="0">
              <a:buNone/>
              <a:defRPr sz="751"/>
            </a:lvl4pPr>
            <a:lvl5pPr marL="1371498" indent="0">
              <a:buNone/>
              <a:defRPr sz="751"/>
            </a:lvl5pPr>
            <a:lvl6pPr marL="1714373" indent="0">
              <a:buNone/>
              <a:defRPr sz="751"/>
            </a:lvl6pPr>
            <a:lvl7pPr marL="2057246" indent="0">
              <a:buNone/>
              <a:defRPr sz="751"/>
            </a:lvl7pPr>
            <a:lvl8pPr marL="2400120" indent="0">
              <a:buNone/>
              <a:defRPr sz="751"/>
            </a:lvl8pPr>
            <a:lvl9pPr marL="2742995" indent="0">
              <a:buNone/>
              <a:defRPr sz="75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AA2CF-4442-4203-9250-C82848ABF354}" type="datetimeFigureOut">
              <a:rPr lang="en-GB" smtClean="0"/>
              <a:t>30/04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02AFB-D7A3-4CD5-9E4B-8229CC00D0F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788545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6" y="1316573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75" indent="0">
              <a:buNone/>
              <a:defRPr sz="2100"/>
            </a:lvl2pPr>
            <a:lvl3pPr marL="685749" indent="0">
              <a:buNone/>
              <a:defRPr sz="1800"/>
            </a:lvl3pPr>
            <a:lvl4pPr marL="1028622" indent="0">
              <a:buNone/>
              <a:defRPr sz="1500"/>
            </a:lvl4pPr>
            <a:lvl5pPr marL="1371498" indent="0">
              <a:buNone/>
              <a:defRPr sz="1500"/>
            </a:lvl5pPr>
            <a:lvl6pPr marL="1714373" indent="0">
              <a:buNone/>
              <a:defRPr sz="1500"/>
            </a:lvl6pPr>
            <a:lvl7pPr marL="2057246" indent="0">
              <a:buNone/>
              <a:defRPr sz="1500"/>
            </a:lvl7pPr>
            <a:lvl8pPr marL="2400120" indent="0">
              <a:buNone/>
              <a:defRPr sz="1500"/>
            </a:lvl8pPr>
            <a:lvl9pPr marL="2742995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75" indent="0">
              <a:buNone/>
              <a:defRPr sz="1051"/>
            </a:lvl2pPr>
            <a:lvl3pPr marL="685749" indent="0">
              <a:buNone/>
              <a:defRPr sz="900"/>
            </a:lvl3pPr>
            <a:lvl4pPr marL="1028622" indent="0">
              <a:buNone/>
              <a:defRPr sz="751"/>
            </a:lvl4pPr>
            <a:lvl5pPr marL="1371498" indent="0">
              <a:buNone/>
              <a:defRPr sz="751"/>
            </a:lvl5pPr>
            <a:lvl6pPr marL="1714373" indent="0">
              <a:buNone/>
              <a:defRPr sz="751"/>
            </a:lvl6pPr>
            <a:lvl7pPr marL="2057246" indent="0">
              <a:buNone/>
              <a:defRPr sz="751"/>
            </a:lvl7pPr>
            <a:lvl8pPr marL="2400120" indent="0">
              <a:buNone/>
              <a:defRPr sz="751"/>
            </a:lvl8pPr>
            <a:lvl9pPr marL="2742995" indent="0">
              <a:buNone/>
              <a:defRPr sz="75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AA2CF-4442-4203-9250-C82848ABF354}" type="datetimeFigureOut">
              <a:rPr lang="en-GB" smtClean="0"/>
              <a:t>30/04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02AFB-D7A3-4CD5-9E4B-8229CC00D0F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817862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40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40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6AA2CF-4442-4203-9250-C82848ABF354}" type="datetimeFigureOut">
              <a:rPr lang="en-GB" smtClean="0"/>
              <a:t>30/04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40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40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102AFB-D7A3-4CD5-9E4B-8229CC00D0F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2385624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49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38" indent="-171438" algn="l" defTabSz="685749" rtl="0" eaLnBrk="1" latinLnBrk="0" hangingPunct="1">
        <a:lnSpc>
          <a:spcPct val="90000"/>
        </a:lnSpc>
        <a:spcBef>
          <a:spcPts val="751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13" indent="-171438" algn="l" defTabSz="68574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86" indent="-171438" algn="l" defTabSz="68574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061" indent="-171438" algn="l" defTabSz="68574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2935" indent="-171438" algn="l" defTabSz="68574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810" indent="-171438" algn="l" defTabSz="68574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684" indent="-171438" algn="l" defTabSz="68574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558" indent="-171438" algn="l" defTabSz="68574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433" indent="-171438" algn="l" defTabSz="68574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49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75" algn="l" defTabSz="685749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49" algn="l" defTabSz="685749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22" algn="l" defTabSz="685749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498" algn="l" defTabSz="685749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373" algn="l" defTabSz="685749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246" algn="l" defTabSz="685749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120" algn="l" defTabSz="685749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2995" algn="l" defTabSz="685749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7" Type="http://schemas.openxmlformats.org/officeDocument/2006/relationships/image" Target="../media/image11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tiff"/><Relationship Id="rId5" Type="http://schemas.openxmlformats.org/officeDocument/2006/relationships/image" Target="../media/image3.tiff"/><Relationship Id="rId4" Type="http://schemas.openxmlformats.org/officeDocument/2006/relationships/image" Target="../media/image9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tiff"/><Relationship Id="rId4" Type="http://schemas.openxmlformats.org/officeDocument/2006/relationships/image" Target="../media/image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5E8BF81F-B302-40A2-8C54-A538BCDD249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53061715"/>
              </p:ext>
            </p:extLst>
          </p:nvPr>
        </p:nvGraphicFramePr>
        <p:xfrm>
          <a:off x="496944" y="262259"/>
          <a:ext cx="5864119" cy="8619525"/>
        </p:xfrm>
        <a:graphic>
          <a:graphicData uri="http://schemas.openxmlformats.org/drawingml/2006/table">
            <a:tbl>
              <a:tblPr/>
              <a:tblGrid>
                <a:gridCol w="1591572">
                  <a:extLst>
                    <a:ext uri="{9D8B030D-6E8A-4147-A177-3AD203B41FA5}">
                      <a16:colId xmlns:a16="http://schemas.microsoft.com/office/drawing/2014/main" val="2543723649"/>
                    </a:ext>
                  </a:extLst>
                </a:gridCol>
                <a:gridCol w="1591572">
                  <a:extLst>
                    <a:ext uri="{9D8B030D-6E8A-4147-A177-3AD203B41FA5}">
                      <a16:colId xmlns:a16="http://schemas.microsoft.com/office/drawing/2014/main" val="346421941"/>
                    </a:ext>
                  </a:extLst>
                </a:gridCol>
                <a:gridCol w="1339116">
                  <a:extLst>
                    <a:ext uri="{9D8B030D-6E8A-4147-A177-3AD203B41FA5}">
                      <a16:colId xmlns:a16="http://schemas.microsoft.com/office/drawing/2014/main" val="1809507094"/>
                    </a:ext>
                  </a:extLst>
                </a:gridCol>
                <a:gridCol w="1341859">
                  <a:extLst>
                    <a:ext uri="{9D8B030D-6E8A-4147-A177-3AD203B41FA5}">
                      <a16:colId xmlns:a16="http://schemas.microsoft.com/office/drawing/2014/main" val="219733266"/>
                    </a:ext>
                  </a:extLst>
                </a:gridCol>
              </a:tblGrid>
              <a:tr h="370575">
                <a:tc gridSpan="4">
                  <a:txBody>
                    <a:bodyPr/>
                    <a:lstStyle/>
                    <a:p>
                      <a:pPr algn="l" rtl="0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ble S1.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croinvertebrate functional traits examined within this study (taken from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che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et al., 2010).</a:t>
                      </a:r>
                    </a:p>
                  </a:txBody>
                  <a:tcPr marL="4815" marR="4815" marT="48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83040092"/>
                  </a:ext>
                </a:extLst>
              </a:tr>
              <a:tr h="187695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ouping feature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ait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ouping feature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ait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9127089"/>
                  </a:ext>
                </a:extLst>
              </a:tr>
              <a:tr h="187695">
                <a:tc rowSpan="7">
                  <a:txBody>
                    <a:bodyPr/>
                    <a:lstStyle/>
                    <a:p>
                      <a:pPr algn="ctr" rtl="0" fontAlgn="ctr"/>
                      <a:r>
                        <a:rPr lang="en-GB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ximum potential size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≤0.25cm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GB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spiration method 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ill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2464693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0.25- 0.5cm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tron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45819244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0.5- 1cm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iracle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580540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- 2cm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drostatic vesicle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0047411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 2- 4 cm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egument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8362799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4- 8cm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9">
                  <a:txBody>
                    <a:bodyPr/>
                    <a:lstStyle/>
                    <a:p>
                      <a:pPr algn="ctr" rtl="0" fontAlgn="ctr"/>
                      <a:r>
                        <a:rPr lang="en-GB" sz="12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od consumed 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croorganisms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4695267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8cm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tritus &lt;1mm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19141045"/>
                  </a:ext>
                </a:extLst>
              </a:tr>
              <a:tr h="187695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GB" sz="12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fe-cycle duration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≤1 year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ad plant ≥1mm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4973416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 year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ving microphyte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7886277"/>
                  </a:ext>
                </a:extLst>
              </a:tr>
              <a:tr h="187695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2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oltinism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1 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ving macrophtye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5609433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ad animal ≥1mm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8769859"/>
                  </a:ext>
                </a:extLst>
              </a:tr>
              <a:tr h="37057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 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ving microinvertebrate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7995362"/>
                  </a:ext>
                </a:extLst>
              </a:tr>
              <a:tr h="187695"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GB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quatic stages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gg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ving invertebrate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1386286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rva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ertebrate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2284149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ymph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8">
                  <a:txBody>
                    <a:bodyPr/>
                    <a:lstStyle/>
                    <a:p>
                      <a:pPr algn="ctr" rtl="0" fontAlgn="ctr"/>
                      <a:r>
                        <a:rPr lang="en-GB" sz="12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eeding group 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bsorber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0443302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ult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posit feeder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02694"/>
                  </a:ext>
                </a:extLst>
              </a:tr>
              <a:tr h="187695">
                <a:tc rowSpan="8">
                  <a:txBody>
                    <a:bodyPr/>
                    <a:lstStyle/>
                    <a:p>
                      <a:pPr algn="ctr" rtl="0" fontAlgn="ctr"/>
                      <a:r>
                        <a:rPr lang="en-GB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production strategy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voviviparity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hredder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4407126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solated, free eggs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raper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74672150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solated, cemented eggs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ilter-feeder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217760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utches, cemented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ercer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2864982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utches, free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dator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5313733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utches, in vegetation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rasite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1974520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utches, terrestrial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14">
                  <a:txBody>
                    <a:bodyPr/>
                    <a:lstStyle/>
                    <a:p>
                      <a:pPr algn="ctr" rtl="0" fontAlgn="ctr"/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6834312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exual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1022561"/>
                  </a:ext>
                </a:extLst>
              </a:tr>
              <a:tr h="187695"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GB" sz="12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spersal strategy 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quatic passive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1324967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quatic active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5238754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erial passive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5730691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erial active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8657322"/>
                  </a:ext>
                </a:extLst>
              </a:tr>
              <a:tr h="187695"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GB" sz="12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sistance form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ggs/statoblasts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2162881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coons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9134096"/>
                  </a:ext>
                </a:extLst>
              </a:tr>
              <a:tr h="37057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ousings against desiccation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l" rtl="0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9556194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apause / dormancy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/>
                      <a:endParaRPr lang="en-GB" sz="10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rtl="0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63903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ne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8343360"/>
                  </a:ext>
                </a:extLst>
              </a:tr>
              <a:tr h="187695">
                <a:tc rowSpan="8">
                  <a:txBody>
                    <a:bodyPr/>
                    <a:lstStyle/>
                    <a:p>
                      <a:pPr algn="ctr" rtl="0" fontAlgn="ctr"/>
                      <a:r>
                        <a:rPr lang="en-GB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comotion and substrate relation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lier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3357246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rface swimmer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l" rtl="0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4690535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ull water swimmer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GB" sz="10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19" marR="6419" marT="64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48220411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rawler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815" marR="4815" marT="48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1021274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urrower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815" marR="4815" marT="48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81136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terstitial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19" marR="6419" marT="64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5931577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emporarily attached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815" marR="4815" marT="48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8212980"/>
                  </a:ext>
                </a:extLst>
              </a:tr>
              <a:tr h="1876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rmanently attached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815" marR="4815" marT="48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815" marR="4815" marT="48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578676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4825809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Picture 21" descr="A graph of a number of different sizes&#10;&#10;Description automatically generated with medium confidence">
            <a:extLst>
              <a:ext uri="{FF2B5EF4-FFF2-40B4-BE49-F238E27FC236}">
                <a16:creationId xmlns:a16="http://schemas.microsoft.com/office/drawing/2014/main" id="{18347978-3047-74CA-D8AC-2B241AF3BCD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655" y="5135752"/>
            <a:ext cx="3287944" cy="3287944"/>
          </a:xfrm>
          <a:prstGeom prst="rect">
            <a:avLst/>
          </a:prstGeom>
        </p:spPr>
      </p:pic>
      <p:pic>
        <p:nvPicPr>
          <p:cNvPr id="20" name="Picture 19" descr="A graph with a number of boxes&#10;&#10;Description automatically generated with medium confidence">
            <a:extLst>
              <a:ext uri="{FF2B5EF4-FFF2-40B4-BE49-F238E27FC236}">
                <a16:creationId xmlns:a16="http://schemas.microsoft.com/office/drawing/2014/main" id="{8639094E-30AF-D2EE-515D-F0206A6A15D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917"/>
          <a:stretch/>
        </p:blipFill>
        <p:spPr>
          <a:xfrm>
            <a:off x="3588828" y="2780884"/>
            <a:ext cx="3276793" cy="2984612"/>
          </a:xfrm>
          <a:prstGeom prst="rect">
            <a:avLst/>
          </a:prstGeom>
        </p:spPr>
      </p:pic>
      <p:pic>
        <p:nvPicPr>
          <p:cNvPr id="9" name="Picture 8" descr="A graph of a graph with a number of boxes&#10;&#10;Description automatically generated with medium confidence">
            <a:extLst>
              <a:ext uri="{FF2B5EF4-FFF2-40B4-BE49-F238E27FC236}">
                <a16:creationId xmlns:a16="http://schemas.microsoft.com/office/drawing/2014/main" id="{C7B535F6-AFC2-8F39-D426-1E97034E664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496" b="9761"/>
          <a:stretch/>
        </p:blipFill>
        <p:spPr>
          <a:xfrm>
            <a:off x="300598" y="83870"/>
            <a:ext cx="3213462" cy="2562526"/>
          </a:xfrm>
          <a:prstGeom prst="rect">
            <a:avLst/>
          </a:prstGeom>
        </p:spPr>
      </p:pic>
      <p:pic>
        <p:nvPicPr>
          <p:cNvPr id="11" name="Picture 10" descr="A graph of a number of different sizes&#10;&#10;Description automatically generated with medium confidence">
            <a:extLst>
              <a:ext uri="{FF2B5EF4-FFF2-40B4-BE49-F238E27FC236}">
                <a16:creationId xmlns:a16="http://schemas.microsoft.com/office/drawing/2014/main" id="{005E4332-1983-5A7E-87F2-4F3F0FC8107B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046" b="7597"/>
          <a:stretch/>
        </p:blipFill>
        <p:spPr>
          <a:xfrm>
            <a:off x="3588828" y="0"/>
            <a:ext cx="3269172" cy="2757790"/>
          </a:xfrm>
          <a:prstGeom prst="rect">
            <a:avLst/>
          </a:prstGeom>
        </p:spPr>
      </p:pic>
      <p:pic>
        <p:nvPicPr>
          <p:cNvPr id="13" name="Picture 12" descr="A graph with a number of boxes&#10;&#10;Description automatically generated with medium confidence">
            <a:extLst>
              <a:ext uri="{FF2B5EF4-FFF2-40B4-BE49-F238E27FC236}">
                <a16:creationId xmlns:a16="http://schemas.microsoft.com/office/drawing/2014/main" id="{1039EDAE-E6D0-FA69-98E6-EDEF304CACD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325" b="9148"/>
          <a:stretch/>
        </p:blipFill>
        <p:spPr>
          <a:xfrm>
            <a:off x="326896" y="2892616"/>
            <a:ext cx="3213462" cy="2523442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521A978C-0CBC-C495-5622-8415402EA896}"/>
              </a:ext>
            </a:extLst>
          </p:cNvPr>
          <p:cNvSpPr txBox="1"/>
          <p:nvPr/>
        </p:nvSpPr>
        <p:spPr>
          <a:xfrm>
            <a:off x="689082" y="-36642"/>
            <a:ext cx="19964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a) Gravel Taxonomi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A546AFC-37ED-F315-6B70-198D3698038D}"/>
              </a:ext>
            </a:extLst>
          </p:cNvPr>
          <p:cNvSpPr txBox="1"/>
          <p:nvPr/>
        </p:nvSpPr>
        <p:spPr>
          <a:xfrm>
            <a:off x="4043502" y="-23094"/>
            <a:ext cx="19964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b) Sand Taxonomi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836F8D0-B0D9-B51F-97D2-DAE3531E070A}"/>
              </a:ext>
            </a:extLst>
          </p:cNvPr>
          <p:cNvSpPr txBox="1"/>
          <p:nvPr/>
        </p:nvSpPr>
        <p:spPr>
          <a:xfrm>
            <a:off x="689082" y="2680413"/>
            <a:ext cx="19964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c) Silt Taxonomic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A5EB0F8-AC09-3D88-C93B-A0BE42076299}"/>
              </a:ext>
            </a:extLst>
          </p:cNvPr>
          <p:cNvSpPr txBox="1"/>
          <p:nvPr/>
        </p:nvSpPr>
        <p:spPr>
          <a:xfrm>
            <a:off x="626391" y="5372478"/>
            <a:ext cx="19964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e) Sand Functional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9AC0C93-0383-D791-21AD-91A8BDEAC79D}"/>
              </a:ext>
            </a:extLst>
          </p:cNvPr>
          <p:cNvSpPr txBox="1"/>
          <p:nvPr/>
        </p:nvSpPr>
        <p:spPr>
          <a:xfrm>
            <a:off x="349074" y="8331767"/>
            <a:ext cx="651654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edian distance to centroid values recorded by a) stream and </a:t>
            </a:r>
            <a:r>
              <a:rPr lang="en-GB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) habitat for taxonomic macroinvertebrate community composition and by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) stream and d</a:t>
            </a:r>
            <a:r>
              <a:rPr lang="en-GB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habitat for functional macroinvertebrate community composition. 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oxes  show the 25</a:t>
            </a:r>
            <a:r>
              <a:rPr lang="en-GB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50</a:t>
            </a:r>
            <a:r>
              <a:rPr lang="en-GB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75</a:t>
            </a:r>
            <a:r>
              <a:rPr lang="en-GB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ercentiles, whiskers the 5</a:t>
            </a:r>
            <a:r>
              <a:rPr lang="en-GB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95</a:t>
            </a:r>
            <a:r>
              <a:rPr lang="en-GB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ercentiles.</a:t>
            </a:r>
            <a:r>
              <a:rPr lang="en-GB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BB48F47-6FC5-0168-A3AF-B806D645E3A0}"/>
              </a:ext>
            </a:extLst>
          </p:cNvPr>
          <p:cNvSpPr txBox="1"/>
          <p:nvPr/>
        </p:nvSpPr>
        <p:spPr>
          <a:xfrm>
            <a:off x="4043502" y="2704476"/>
            <a:ext cx="19964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d) Gravel Functional</a:t>
            </a:r>
          </a:p>
        </p:txBody>
      </p:sp>
      <p:pic>
        <p:nvPicPr>
          <p:cNvPr id="5" name="Picture 4" descr="A graph with a number of boxes&#10;&#10;Description automatically generated with medium confidence">
            <a:extLst>
              <a:ext uri="{FF2B5EF4-FFF2-40B4-BE49-F238E27FC236}">
                <a16:creationId xmlns:a16="http://schemas.microsoft.com/office/drawing/2014/main" id="{305A9F9B-733E-7711-8679-8AC51914F50F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000" r="3899"/>
          <a:stretch/>
        </p:blipFill>
        <p:spPr>
          <a:xfrm>
            <a:off x="3638711" y="5416058"/>
            <a:ext cx="3141706" cy="3007638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D17408B8-776C-6CA1-F566-A92F6985DF88}"/>
              </a:ext>
            </a:extLst>
          </p:cNvPr>
          <p:cNvSpPr txBox="1"/>
          <p:nvPr/>
        </p:nvSpPr>
        <p:spPr>
          <a:xfrm>
            <a:off x="4065088" y="5372479"/>
            <a:ext cx="19964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f) Silt Functional</a:t>
            </a:r>
          </a:p>
        </p:txBody>
      </p:sp>
    </p:spTree>
    <p:extLst>
      <p:ext uri="{BB962C8B-B14F-4D97-AF65-F5344CB8AC3E}">
        <p14:creationId xmlns:p14="http://schemas.microsoft.com/office/powerpoint/2010/main" val="35110615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AC481280-B4D1-B63C-45FD-7605526068A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57007285"/>
              </p:ext>
            </p:extLst>
          </p:nvPr>
        </p:nvGraphicFramePr>
        <p:xfrm>
          <a:off x="200429" y="628851"/>
          <a:ext cx="6457142" cy="3758886"/>
        </p:xfrm>
        <a:graphic>
          <a:graphicData uri="http://schemas.openxmlformats.org/drawingml/2006/table">
            <a:tbl>
              <a:tblPr/>
              <a:tblGrid>
                <a:gridCol w="1198065">
                  <a:extLst>
                    <a:ext uri="{9D8B030D-6E8A-4147-A177-3AD203B41FA5}">
                      <a16:colId xmlns:a16="http://schemas.microsoft.com/office/drawing/2014/main" val="764876166"/>
                    </a:ext>
                  </a:extLst>
                </a:gridCol>
                <a:gridCol w="861773">
                  <a:extLst>
                    <a:ext uri="{9D8B030D-6E8A-4147-A177-3AD203B41FA5}">
                      <a16:colId xmlns:a16="http://schemas.microsoft.com/office/drawing/2014/main" val="3698916257"/>
                    </a:ext>
                  </a:extLst>
                </a:gridCol>
                <a:gridCol w="1029919">
                  <a:extLst>
                    <a:ext uri="{9D8B030D-6E8A-4147-A177-3AD203B41FA5}">
                      <a16:colId xmlns:a16="http://schemas.microsoft.com/office/drawing/2014/main" val="2355209114"/>
                    </a:ext>
                  </a:extLst>
                </a:gridCol>
                <a:gridCol w="1164255">
                  <a:extLst>
                    <a:ext uri="{9D8B030D-6E8A-4147-A177-3AD203B41FA5}">
                      <a16:colId xmlns:a16="http://schemas.microsoft.com/office/drawing/2014/main" val="4276944586"/>
                    </a:ext>
                  </a:extLst>
                </a:gridCol>
                <a:gridCol w="1101565">
                  <a:extLst>
                    <a:ext uri="{9D8B030D-6E8A-4147-A177-3AD203B41FA5}">
                      <a16:colId xmlns:a16="http://schemas.microsoft.com/office/drawing/2014/main" val="112364265"/>
                    </a:ext>
                  </a:extLst>
                </a:gridCol>
                <a:gridCol w="1101565">
                  <a:extLst>
                    <a:ext uri="{9D8B030D-6E8A-4147-A177-3AD203B41FA5}">
                      <a16:colId xmlns:a16="http://schemas.microsoft.com/office/drawing/2014/main" val="4049064647"/>
                    </a:ext>
                  </a:extLst>
                </a:gridCol>
              </a:tblGrid>
              <a:tr h="371387">
                <a:tc gridSpan="6">
                  <a:txBody>
                    <a:bodyPr/>
                    <a:lstStyle/>
                    <a:p>
                      <a:pPr algn="l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ble S2. </a:t>
                      </a:r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mmary of the indicator families identified for each habitat group. Only significant (p&lt;0.05) indicator values (&gt;0.25) and those with a fidelity value of &gt;0.25 are presented. 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78267453"/>
                  </a:ext>
                </a:extLst>
              </a:tr>
              <a:tr h="188507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bstrate composition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dicator value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 value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bitat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dicator value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 value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32120582"/>
                  </a:ext>
                </a:extLst>
              </a:tr>
              <a:tr h="188507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avel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ilt 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0740065"/>
                  </a:ext>
                </a:extLst>
              </a:tr>
              <a:tr h="188507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mida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10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dirty="0">
                          <a:effectLst/>
                        </a:rPr>
                        <a:t>Chironomida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63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4474616"/>
                  </a:ext>
                </a:extLst>
              </a:tr>
              <a:tr h="188507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mmaridae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03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dirty="0">
                          <a:effectLst/>
                        </a:rPr>
                        <a:t>Oligochaeta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45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34922223"/>
                  </a:ext>
                </a:extLst>
              </a:tr>
              <a:tr h="188507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etida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66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dirty="0">
                          <a:effectLst/>
                        </a:rPr>
                        <a:t>Sphaeriida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36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34185526"/>
                  </a:ext>
                </a:extLst>
              </a:tr>
              <a:tr h="188507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dirty="0" err="1">
                          <a:effectLst/>
                        </a:rPr>
                        <a:t>Hydropsychida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30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dirty="0" err="1">
                          <a:effectLst/>
                        </a:rPr>
                        <a:t>Glossiphoniida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52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749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31045992"/>
                  </a:ext>
                </a:extLst>
              </a:tr>
              <a:tr h="188507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dirty="0" err="1">
                          <a:effectLst/>
                        </a:rPr>
                        <a:t>Ephemerellida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08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dirty="0" err="1">
                          <a:effectLst/>
                        </a:rPr>
                        <a:t>Corixidae.spp</a:t>
                      </a:r>
                      <a:r>
                        <a:rPr lang="en-GB" sz="1200" dirty="0">
                          <a:effectLst/>
                        </a:rPr>
                        <a:t>.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01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749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6923582"/>
                  </a:ext>
                </a:extLst>
              </a:tr>
              <a:tr h="188507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dirty="0" err="1">
                          <a:effectLst/>
                        </a:rPr>
                        <a:t>Leuctrida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61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dirty="0" err="1">
                          <a:effectLst/>
                        </a:rPr>
                        <a:t>Erpobdellidae</a:t>
                      </a:r>
                      <a:r>
                        <a:rPr lang="en-GB" sz="1200" dirty="0">
                          <a:effectLst/>
                        </a:rPr>
                        <a:t> 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73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749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09283689"/>
                  </a:ext>
                </a:extLst>
              </a:tr>
              <a:tr h="188507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dirty="0" err="1">
                          <a:effectLst/>
                        </a:rPr>
                        <a:t>Rhyacophilida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94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749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dirty="0" err="1">
                          <a:effectLst/>
                        </a:rPr>
                        <a:t>Sialida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17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4671967"/>
                  </a:ext>
                </a:extLst>
              </a:tr>
              <a:tr h="188507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dirty="0" err="1">
                          <a:effectLst/>
                        </a:rPr>
                        <a:t>Tipulida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60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749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dirty="0">
                          <a:effectLst/>
                        </a:rPr>
                        <a:t>Ceratopogonida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11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3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28273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dirty="0" err="1">
                          <a:effectLst/>
                        </a:rPr>
                        <a:t>Ancylida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44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749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dirty="0" err="1">
                          <a:effectLst/>
                        </a:rPr>
                        <a:t>Caenidae</a:t>
                      </a:r>
                      <a:r>
                        <a:rPr lang="en-GB" sz="1200" dirty="0">
                          <a:effectLst/>
                        </a:rPr>
                        <a:t> 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78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4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23096668"/>
                  </a:ext>
                </a:extLst>
              </a:tr>
              <a:tr h="188507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dirty="0" err="1">
                          <a:effectLst/>
                        </a:rPr>
                        <a:t>Brachycentroidae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42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dirty="0" err="1">
                          <a:effectLst/>
                        </a:rPr>
                        <a:t>Asellida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76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6330633"/>
                  </a:ext>
                </a:extLst>
              </a:tr>
              <a:tr h="188507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dirty="0" err="1">
                          <a:effectLst/>
                        </a:rPr>
                        <a:t>Simuliidae</a:t>
                      </a:r>
                      <a:r>
                        <a:rPr lang="en-GB" sz="1200" dirty="0">
                          <a:effectLst/>
                        </a:rPr>
                        <a:t> 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15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4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dirty="0" err="1">
                          <a:effectLst/>
                        </a:rPr>
                        <a:t>Dytiscida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54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749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8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81945340"/>
                  </a:ext>
                </a:extLst>
              </a:tr>
              <a:tr h="188507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dirty="0" err="1">
                          <a:effectLst/>
                        </a:rPr>
                        <a:t>Leptocerida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91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9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60142891"/>
                  </a:ext>
                </a:extLst>
              </a:tr>
              <a:tr h="188507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dirty="0" err="1">
                          <a:effectLst/>
                        </a:rPr>
                        <a:t>Lymnaeida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43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8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nd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4234420"/>
                  </a:ext>
                </a:extLst>
              </a:tr>
              <a:tr h="188507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dirty="0" err="1">
                          <a:effectLst/>
                        </a:rPr>
                        <a:t>Hydracarina</a:t>
                      </a:r>
                      <a:r>
                        <a:rPr lang="en-GB" sz="1200" dirty="0">
                          <a:effectLst/>
                        </a:rPr>
                        <a:t> 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34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6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dirty="0" err="1">
                          <a:effectLst/>
                        </a:rPr>
                        <a:t>Sericostomatida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64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8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8788794"/>
                  </a:ext>
                </a:extLst>
              </a:tr>
              <a:tr h="188507"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dirty="0">
                          <a:effectLst/>
                        </a:rPr>
                        <a:t>Ephemerida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34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1</a:t>
                      </a:r>
                    </a:p>
                  </a:txBody>
                  <a:tcPr marL="5627" marR="5627" marT="5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9241501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230260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A3B2B5D5-0241-898D-1B46-E7C2861DD28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51152009"/>
              </p:ext>
            </p:extLst>
          </p:nvPr>
        </p:nvGraphicFramePr>
        <p:xfrm>
          <a:off x="1925340" y="574432"/>
          <a:ext cx="2635750" cy="5802309"/>
        </p:xfrm>
        <a:graphic>
          <a:graphicData uri="http://schemas.openxmlformats.org/drawingml/2006/table">
            <a:tbl>
              <a:tblPr/>
              <a:tblGrid>
                <a:gridCol w="1464306">
                  <a:extLst>
                    <a:ext uri="{9D8B030D-6E8A-4147-A177-3AD203B41FA5}">
                      <a16:colId xmlns:a16="http://schemas.microsoft.com/office/drawing/2014/main" val="1762163263"/>
                    </a:ext>
                  </a:extLst>
                </a:gridCol>
                <a:gridCol w="585722">
                  <a:extLst>
                    <a:ext uri="{9D8B030D-6E8A-4147-A177-3AD203B41FA5}">
                      <a16:colId xmlns:a16="http://schemas.microsoft.com/office/drawing/2014/main" val="4060872131"/>
                    </a:ext>
                  </a:extLst>
                </a:gridCol>
                <a:gridCol w="585722">
                  <a:extLst>
                    <a:ext uri="{9D8B030D-6E8A-4147-A177-3AD203B41FA5}">
                      <a16:colId xmlns:a16="http://schemas.microsoft.com/office/drawing/2014/main" val="2856454944"/>
                    </a:ext>
                  </a:extLst>
                </a:gridCol>
              </a:tblGrid>
              <a:tr h="979255">
                <a:tc gridSpan="3">
                  <a:txBody>
                    <a:bodyPr/>
                    <a:lstStyle/>
                    <a:p>
                      <a:pPr algn="l" rtl="0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ble S3. </a:t>
                      </a:r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mmary of linear model output examining  statistical differences in six macroinvertebrate community metrics associated with habitat, river and their interaction. 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16114777"/>
                  </a:ext>
                </a:extLst>
              </a:tr>
              <a:tr h="21049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ctors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 value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1477294"/>
                  </a:ext>
                </a:extLst>
              </a:tr>
              <a:tr h="19219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bundance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8541679"/>
                  </a:ext>
                </a:extLst>
              </a:tr>
              <a:tr h="192190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bitat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54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6220595"/>
                  </a:ext>
                </a:extLst>
              </a:tr>
              <a:tr h="192190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iver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.31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5603120"/>
                  </a:ext>
                </a:extLst>
              </a:tr>
              <a:tr h="192190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iver x Habitat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33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9040813"/>
                  </a:ext>
                </a:extLst>
              </a:tr>
              <a:tr h="19219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xa richness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93989749"/>
                  </a:ext>
                </a:extLst>
              </a:tr>
              <a:tr h="192190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bitat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.20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4090830"/>
                  </a:ext>
                </a:extLst>
              </a:tr>
              <a:tr h="192190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iver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.90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3404649"/>
                  </a:ext>
                </a:extLst>
              </a:tr>
              <a:tr h="192190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iver x Habitat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51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7900304"/>
                  </a:ext>
                </a:extLst>
              </a:tr>
              <a:tr h="19219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PT richness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1710788"/>
                  </a:ext>
                </a:extLst>
              </a:tr>
              <a:tr h="192190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bitat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.77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4999634"/>
                  </a:ext>
                </a:extLst>
              </a:tr>
              <a:tr h="192190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iver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.09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3177800"/>
                  </a:ext>
                </a:extLst>
              </a:tr>
              <a:tr h="192190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iver x Habitat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50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10548412"/>
                  </a:ext>
                </a:extLst>
              </a:tr>
              <a:tr h="19219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unctional Richness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1621255"/>
                  </a:ext>
                </a:extLst>
              </a:tr>
              <a:tr h="192190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bitat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56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9678384"/>
                  </a:ext>
                </a:extLst>
              </a:tr>
              <a:tr h="192190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iver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63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6686903"/>
                  </a:ext>
                </a:extLst>
              </a:tr>
              <a:tr h="192190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iver x Habitat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30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8426388"/>
                  </a:ext>
                </a:extLst>
              </a:tr>
              <a:tr h="19219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unctional Evenness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20354014"/>
                  </a:ext>
                </a:extLst>
              </a:tr>
              <a:tr h="192190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bitat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45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11497395"/>
                  </a:ext>
                </a:extLst>
              </a:tr>
              <a:tr h="192190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iver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60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99096744"/>
                  </a:ext>
                </a:extLst>
              </a:tr>
              <a:tr h="192190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iver x Habitat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35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0216877"/>
                  </a:ext>
                </a:extLst>
              </a:tr>
              <a:tr h="19219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unctional Divergence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8286152"/>
                  </a:ext>
                </a:extLst>
              </a:tr>
              <a:tr h="192190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bitat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51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1070640"/>
                  </a:ext>
                </a:extLst>
              </a:tr>
              <a:tr h="192190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iver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53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7295893"/>
                  </a:ext>
                </a:extLst>
              </a:tr>
              <a:tr h="192190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iver x Habitat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3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0</a:t>
                      </a:r>
                    </a:p>
                  </a:txBody>
                  <a:tcPr marL="9152" marR="9152" marT="9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463142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575359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45195814-5D50-ADA3-F0B1-BC87D382384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07424186"/>
              </p:ext>
            </p:extLst>
          </p:nvPr>
        </p:nvGraphicFramePr>
        <p:xfrm>
          <a:off x="100034" y="174922"/>
          <a:ext cx="6657931" cy="8342648"/>
        </p:xfrm>
        <a:graphic>
          <a:graphicData uri="http://schemas.openxmlformats.org/drawingml/2006/table">
            <a:tbl>
              <a:tblPr firstRow="1" firstCol="1" bandRow="1"/>
              <a:tblGrid>
                <a:gridCol w="877385">
                  <a:extLst>
                    <a:ext uri="{9D8B030D-6E8A-4147-A177-3AD203B41FA5}">
                      <a16:colId xmlns:a16="http://schemas.microsoft.com/office/drawing/2014/main" val="2086324974"/>
                    </a:ext>
                  </a:extLst>
                </a:gridCol>
                <a:gridCol w="582910">
                  <a:extLst>
                    <a:ext uri="{9D8B030D-6E8A-4147-A177-3AD203B41FA5}">
                      <a16:colId xmlns:a16="http://schemas.microsoft.com/office/drawing/2014/main" val="545767659"/>
                    </a:ext>
                  </a:extLst>
                </a:gridCol>
                <a:gridCol w="582240">
                  <a:extLst>
                    <a:ext uri="{9D8B030D-6E8A-4147-A177-3AD203B41FA5}">
                      <a16:colId xmlns:a16="http://schemas.microsoft.com/office/drawing/2014/main" val="521067269"/>
                    </a:ext>
                  </a:extLst>
                </a:gridCol>
                <a:gridCol w="192219">
                  <a:extLst>
                    <a:ext uri="{9D8B030D-6E8A-4147-A177-3AD203B41FA5}">
                      <a16:colId xmlns:a16="http://schemas.microsoft.com/office/drawing/2014/main" val="2570721574"/>
                    </a:ext>
                  </a:extLst>
                </a:gridCol>
                <a:gridCol w="910253">
                  <a:extLst>
                    <a:ext uri="{9D8B030D-6E8A-4147-A177-3AD203B41FA5}">
                      <a16:colId xmlns:a16="http://schemas.microsoft.com/office/drawing/2014/main" val="4079978342"/>
                    </a:ext>
                  </a:extLst>
                </a:gridCol>
                <a:gridCol w="582910">
                  <a:extLst>
                    <a:ext uri="{9D8B030D-6E8A-4147-A177-3AD203B41FA5}">
                      <a16:colId xmlns:a16="http://schemas.microsoft.com/office/drawing/2014/main" val="832593452"/>
                    </a:ext>
                  </a:extLst>
                </a:gridCol>
                <a:gridCol w="582910">
                  <a:extLst>
                    <a:ext uri="{9D8B030D-6E8A-4147-A177-3AD203B41FA5}">
                      <a16:colId xmlns:a16="http://schemas.microsoft.com/office/drawing/2014/main" val="2430887584"/>
                    </a:ext>
                  </a:extLst>
                </a:gridCol>
                <a:gridCol w="192219">
                  <a:extLst>
                    <a:ext uri="{9D8B030D-6E8A-4147-A177-3AD203B41FA5}">
                      <a16:colId xmlns:a16="http://schemas.microsoft.com/office/drawing/2014/main" val="3661766602"/>
                    </a:ext>
                  </a:extLst>
                </a:gridCol>
                <a:gridCol w="872019">
                  <a:extLst>
                    <a:ext uri="{9D8B030D-6E8A-4147-A177-3AD203B41FA5}">
                      <a16:colId xmlns:a16="http://schemas.microsoft.com/office/drawing/2014/main" val="2094747350"/>
                    </a:ext>
                  </a:extLst>
                </a:gridCol>
                <a:gridCol w="582240">
                  <a:extLst>
                    <a:ext uri="{9D8B030D-6E8A-4147-A177-3AD203B41FA5}">
                      <a16:colId xmlns:a16="http://schemas.microsoft.com/office/drawing/2014/main" val="830334639"/>
                    </a:ext>
                  </a:extLst>
                </a:gridCol>
                <a:gridCol w="582240">
                  <a:extLst>
                    <a:ext uri="{9D8B030D-6E8A-4147-A177-3AD203B41FA5}">
                      <a16:colId xmlns:a16="http://schemas.microsoft.com/office/drawing/2014/main" val="2374257519"/>
                    </a:ext>
                  </a:extLst>
                </a:gridCol>
                <a:gridCol w="118386">
                  <a:extLst>
                    <a:ext uri="{9D8B030D-6E8A-4147-A177-3AD203B41FA5}">
                      <a16:colId xmlns:a16="http://schemas.microsoft.com/office/drawing/2014/main" val="1253176185"/>
                    </a:ext>
                  </a:extLst>
                </a:gridCol>
              </a:tblGrid>
              <a:tr h="287399">
                <a:tc gridSpan="12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able S4.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Summary of pairwise post-hoc tests assessing differences in each community metric by habitat for each individual river and for all data combined.  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43443355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bundance 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axa richness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EPT richness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59396716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2679107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rome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rome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rome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9296414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78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22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7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873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18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264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59453055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39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103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189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9254463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3448466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adder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adder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adder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5818299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45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0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49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44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407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62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3482341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193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47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273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7929880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4152510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Little Stour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Little Stour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Little Stour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7337910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446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&lt;0.00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48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557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08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465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4076519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&lt;0.00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466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49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3450313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89330822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ill Stream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ill Stream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ill Stream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514052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&lt;0.00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214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&lt;0.00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&lt;0.00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&lt;0.00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&lt;0.00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83563512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&lt;0.00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&lt;0.00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04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9448255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1882008"/>
                  </a:ext>
                </a:extLst>
              </a:tr>
              <a:tr h="19406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ool Stream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ool Stream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ool Stream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9296481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&lt;0.00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677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18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&lt;0.00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06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&lt;0.00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6753302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&lt;0.00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207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122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9275124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6908120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ll dat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ll dat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ll dat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340794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&lt;0.00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74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&lt;0.00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&lt;0.00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&lt;0.00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&lt;0.001</a:t>
                      </a:r>
                      <a:endParaRPr lang="en-GB" sz="10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4586772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09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89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365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6930207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52549992"/>
                  </a:ext>
                </a:extLst>
              </a:tr>
              <a:tr h="140438">
                <a:tc gridSpan="2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unctional Richness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unctional Evenness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unctional Divergence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22410928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0618682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rome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rome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rome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09892332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33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116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35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189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807</a:t>
                      </a:r>
                      <a:endParaRPr lang="en-GB" sz="10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357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18697209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17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376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55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4781602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3468629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adder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adder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adder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55792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248</a:t>
                      </a:r>
                      <a:endParaRPr lang="en-GB" sz="10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290</a:t>
                      </a:r>
                      <a:endParaRPr lang="en-GB" sz="10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86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359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450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466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9923819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56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45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99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9015273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1665842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Little Stour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Little Stour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Little Stour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09420105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480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340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485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&lt;0.00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383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98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1784665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782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&lt;0.00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383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6285157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5141932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ill Stream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ill Stream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ill Stream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0647142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&lt;0.00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15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29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300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34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200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196378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&lt;0.00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238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&lt;0.00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85493152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00922194"/>
                  </a:ext>
                </a:extLst>
              </a:tr>
              <a:tr h="19406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ool Stream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ool Stream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ool Stream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95114435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2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14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526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51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406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&lt;0.00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53733725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892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22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&lt;0.00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74357296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51238597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ll dat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ll dat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ll dat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l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00560208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&lt;0.00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247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02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05</a:t>
                      </a:r>
                      <a:endParaRPr lang="en-GB" sz="10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rave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53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&lt;0.00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83780361"/>
                  </a:ext>
                </a:extLst>
              </a:tr>
              <a:tr h="14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&lt;0.00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767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n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&lt;0.00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2092" marR="4209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369109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5675926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D7005DF2-F76C-8FD8-CC81-CD5E5B22047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69256239"/>
              </p:ext>
            </p:extLst>
          </p:nvPr>
        </p:nvGraphicFramePr>
        <p:xfrm>
          <a:off x="1176803" y="238716"/>
          <a:ext cx="4504393" cy="8666567"/>
        </p:xfrm>
        <a:graphic>
          <a:graphicData uri="http://schemas.openxmlformats.org/drawingml/2006/table">
            <a:tbl>
              <a:tblPr/>
              <a:tblGrid>
                <a:gridCol w="896894">
                  <a:extLst>
                    <a:ext uri="{9D8B030D-6E8A-4147-A177-3AD203B41FA5}">
                      <a16:colId xmlns:a16="http://schemas.microsoft.com/office/drawing/2014/main" val="3258326428"/>
                    </a:ext>
                  </a:extLst>
                </a:gridCol>
                <a:gridCol w="896894">
                  <a:extLst>
                    <a:ext uri="{9D8B030D-6E8A-4147-A177-3AD203B41FA5}">
                      <a16:colId xmlns:a16="http://schemas.microsoft.com/office/drawing/2014/main" val="3277696296"/>
                    </a:ext>
                  </a:extLst>
                </a:gridCol>
                <a:gridCol w="903535">
                  <a:extLst>
                    <a:ext uri="{9D8B030D-6E8A-4147-A177-3AD203B41FA5}">
                      <a16:colId xmlns:a16="http://schemas.microsoft.com/office/drawing/2014/main" val="715874586"/>
                    </a:ext>
                  </a:extLst>
                </a:gridCol>
                <a:gridCol w="903535">
                  <a:extLst>
                    <a:ext uri="{9D8B030D-6E8A-4147-A177-3AD203B41FA5}">
                      <a16:colId xmlns:a16="http://schemas.microsoft.com/office/drawing/2014/main" val="1578236053"/>
                    </a:ext>
                  </a:extLst>
                </a:gridCol>
                <a:gridCol w="903535">
                  <a:extLst>
                    <a:ext uri="{9D8B030D-6E8A-4147-A177-3AD203B41FA5}">
                      <a16:colId xmlns:a16="http://schemas.microsoft.com/office/drawing/2014/main" val="2925580460"/>
                    </a:ext>
                  </a:extLst>
                </a:gridCol>
              </a:tblGrid>
              <a:tr h="550430">
                <a:tc gridSpan="5">
                  <a:txBody>
                    <a:bodyPr/>
                    <a:lstStyle/>
                    <a:p>
                      <a:pPr algn="l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ble S5. </a:t>
                      </a:r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irwise post-hoc tests of homogeneity of multivariate dispersion values between each stream for a) taxonomic and b) functional community composition. Significant (p&lt;0.05) results are in bold. 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93012491"/>
                  </a:ext>
                </a:extLst>
              </a:tr>
              <a:tr h="187387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) Gravel Taxonomic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4663024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ream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dder</a:t>
                      </a:r>
                    </a:p>
                  </a:txBody>
                  <a:tcPr marL="5909" marR="5909" marT="5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ttle Stour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 Stream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ool Stream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98117133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ome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5909" marR="5909" marT="590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42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3768735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dder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19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36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86628561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ttle Stour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6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9761533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 Stream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09" marR="5909" marT="5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6792876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1901175"/>
                  </a:ext>
                </a:extLst>
              </a:tr>
              <a:tr h="187387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) Sand Taxonomic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96426299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ream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dder</a:t>
                      </a:r>
                    </a:p>
                  </a:txBody>
                  <a:tcPr marL="5909" marR="5909" marT="5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ttle Stour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 Stream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ool Stream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12206612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ome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5909" marR="5909" marT="590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34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47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4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44922286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dder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7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9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4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69714383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ttle Stour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95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46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51051327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 Stream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09" marR="5909" marT="5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11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13755830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75973762"/>
                  </a:ext>
                </a:extLst>
              </a:tr>
              <a:tr h="187387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) Silt Taxonomic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18981577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ream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dder</a:t>
                      </a:r>
                    </a:p>
                  </a:txBody>
                  <a:tcPr marL="5909" marR="5909" marT="5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ttle Stour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 Stream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ool Stream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67470349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ome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5909" marR="5909" marT="590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5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51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6836678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dder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57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48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91912686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ttle Stour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0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48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15489158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 Stream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09" marR="5909" marT="5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4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14138882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36484185"/>
                  </a:ext>
                </a:extLst>
              </a:tr>
              <a:tr h="187387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) Gravel Functional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31232638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ream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dder</a:t>
                      </a:r>
                    </a:p>
                  </a:txBody>
                  <a:tcPr marL="5909" marR="5909" marT="5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ttle Stour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 Stream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ool Stream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96687400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ome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5909" marR="5909" marT="590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79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20805489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dder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96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4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43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1707831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ttle Stour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6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14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20319073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 Stream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09" marR="5909" marT="5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1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49509308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39123331"/>
                  </a:ext>
                </a:extLst>
              </a:tr>
              <a:tr h="187387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) Sand Functional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3055535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ream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dder</a:t>
                      </a:r>
                    </a:p>
                  </a:txBody>
                  <a:tcPr marL="5909" marR="5909" marT="5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ttle Stour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 Stream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ool Stream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87169300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ome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4</a:t>
                      </a:r>
                    </a:p>
                  </a:txBody>
                  <a:tcPr marL="5909" marR="5909" marT="590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49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89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12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84224343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dder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44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31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38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79157851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ttle Stour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96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89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11436106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 Stream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09" marR="5909" marT="5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96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54746459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13364028"/>
                  </a:ext>
                </a:extLst>
              </a:tr>
              <a:tr h="187387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) Silt Functional 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4689329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ream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dder</a:t>
                      </a:r>
                    </a:p>
                  </a:txBody>
                  <a:tcPr marL="5909" marR="5909" marT="5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ttle Stour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 Stream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ool Stream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67937468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ome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</a:t>
                      </a:r>
                    </a:p>
                  </a:txBody>
                  <a:tcPr marL="5909" marR="5909" marT="590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37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90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4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5945833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dder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88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3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79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656868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ttle Stour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71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47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87519506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 Stream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09" marR="5909" marT="5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2</a:t>
                      </a:r>
                    </a:p>
                  </a:txBody>
                  <a:tcPr marL="5909" marR="5909" marT="59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5054557"/>
                  </a:ext>
                </a:extLst>
              </a:tr>
              <a:tr h="187387"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5909" marR="5909" marT="5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3766966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1906128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F7809151-D52E-180B-E5F8-F0DE5B38A0B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51482029"/>
              </p:ext>
            </p:extLst>
          </p:nvPr>
        </p:nvGraphicFramePr>
        <p:xfrm>
          <a:off x="1053098" y="459748"/>
          <a:ext cx="4971619" cy="3316605"/>
        </p:xfrm>
        <a:graphic>
          <a:graphicData uri="http://schemas.openxmlformats.org/drawingml/2006/table">
            <a:tbl>
              <a:tblPr/>
              <a:tblGrid>
                <a:gridCol w="1115227">
                  <a:extLst>
                    <a:ext uri="{9D8B030D-6E8A-4147-A177-3AD203B41FA5}">
                      <a16:colId xmlns:a16="http://schemas.microsoft.com/office/drawing/2014/main" val="3106095838"/>
                    </a:ext>
                  </a:extLst>
                </a:gridCol>
                <a:gridCol w="936210">
                  <a:extLst>
                    <a:ext uri="{9D8B030D-6E8A-4147-A177-3AD203B41FA5}">
                      <a16:colId xmlns:a16="http://schemas.microsoft.com/office/drawing/2014/main" val="3330880284"/>
                    </a:ext>
                  </a:extLst>
                </a:gridCol>
                <a:gridCol w="1137904">
                  <a:extLst>
                    <a:ext uri="{9D8B030D-6E8A-4147-A177-3AD203B41FA5}">
                      <a16:colId xmlns:a16="http://schemas.microsoft.com/office/drawing/2014/main" val="3750327055"/>
                    </a:ext>
                  </a:extLst>
                </a:gridCol>
                <a:gridCol w="853129">
                  <a:extLst>
                    <a:ext uri="{9D8B030D-6E8A-4147-A177-3AD203B41FA5}">
                      <a16:colId xmlns:a16="http://schemas.microsoft.com/office/drawing/2014/main" val="2053403207"/>
                    </a:ext>
                  </a:extLst>
                </a:gridCol>
                <a:gridCol w="929149">
                  <a:extLst>
                    <a:ext uri="{9D8B030D-6E8A-4147-A177-3AD203B41FA5}">
                      <a16:colId xmlns:a16="http://schemas.microsoft.com/office/drawing/2014/main" val="3403597364"/>
                    </a:ext>
                  </a:extLst>
                </a:gridCol>
              </a:tblGrid>
              <a:tr h="838200">
                <a:tc gridSpan="5">
                  <a:txBody>
                    <a:bodyPr/>
                    <a:lstStyle/>
                    <a:p>
                      <a:pPr algn="l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able S6. </a:t>
                      </a:r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airwise post-hoc tests of homogeneity of multivariate dispersion values between each stream for a) taxonomic and b) functional community composition. Significant (p&lt;0.05) results are in bold. </a:t>
                      </a:r>
                    </a:p>
                    <a:p>
                      <a:pPr algn="l" fontAlgn="b"/>
                      <a:b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</a:br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) Taxonomi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73683739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trea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adde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ittle Stou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ill Strea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Wool Strea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9459535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rom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&lt;0.00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2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87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&lt;0.0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1833666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adde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&lt;0.0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&lt;0.0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1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47657873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ittle Stou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8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2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1065345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ill Strea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&lt;0.0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0108753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6747965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) Functional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9979727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trea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adde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ittle Stou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ill Strea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Wool Strea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54472612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rom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&lt;0.00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99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99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1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73054043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adde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&lt;0.0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&lt;0.0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8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72917168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ittle Stou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96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6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37355753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ill Strea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0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298538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7455487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26D1B029-7920-61CD-7852-E8432512CB2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80850990"/>
              </p:ext>
            </p:extLst>
          </p:nvPr>
        </p:nvGraphicFramePr>
        <p:xfrm>
          <a:off x="2127591" y="369093"/>
          <a:ext cx="2296587" cy="2434592"/>
        </p:xfrm>
        <a:graphic>
          <a:graphicData uri="http://schemas.openxmlformats.org/drawingml/2006/table">
            <a:tbl>
              <a:tblPr/>
              <a:tblGrid>
                <a:gridCol w="941917">
                  <a:extLst>
                    <a:ext uri="{9D8B030D-6E8A-4147-A177-3AD203B41FA5}">
                      <a16:colId xmlns:a16="http://schemas.microsoft.com/office/drawing/2014/main" val="11933189"/>
                    </a:ext>
                  </a:extLst>
                </a:gridCol>
                <a:gridCol w="677335">
                  <a:extLst>
                    <a:ext uri="{9D8B030D-6E8A-4147-A177-3AD203B41FA5}">
                      <a16:colId xmlns:a16="http://schemas.microsoft.com/office/drawing/2014/main" val="3483225601"/>
                    </a:ext>
                  </a:extLst>
                </a:gridCol>
                <a:gridCol w="677335">
                  <a:extLst>
                    <a:ext uri="{9D8B030D-6E8A-4147-A177-3AD203B41FA5}">
                      <a16:colId xmlns:a16="http://schemas.microsoft.com/office/drawing/2014/main" val="4272745119"/>
                    </a:ext>
                  </a:extLst>
                </a:gridCol>
              </a:tblGrid>
              <a:tr h="738664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ble S7. </a:t>
                      </a:r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mmary statistics of Kruskal-Wallis tests examining statistical differences in LCBD values between habitat type by river. Significant (p&lt;0.05) results are in bold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>
                    <a:lnL w="12700" cmpd="sng">
                      <a:noFill/>
                      <a:prstDash val="solid"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08074626"/>
                  </a:ext>
                </a:extLst>
              </a:tr>
              <a:tr h="190024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iver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χ</a:t>
                      </a:r>
                      <a:r>
                        <a:rPr lang="el-GR" sz="12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  <a:r>
                        <a:rPr lang="el-G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endParaRPr lang="el-GR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6447688"/>
                  </a:ext>
                </a:extLst>
              </a:tr>
              <a:tr h="190024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ome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22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4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7356671"/>
                  </a:ext>
                </a:extLst>
              </a:tr>
              <a:tr h="190024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dder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56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8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3793993"/>
                  </a:ext>
                </a:extLst>
              </a:tr>
              <a:tr h="190024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ttle Stour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00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8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7210152"/>
                  </a:ext>
                </a:extLst>
              </a:tr>
              <a:tr h="190024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 Stream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02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1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16205666"/>
                  </a:ext>
                </a:extLst>
              </a:tr>
              <a:tr h="116687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ool Stream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03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0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630089"/>
                  </a:ext>
                </a:extLst>
              </a:tr>
              <a:tr h="116687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l Data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89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2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07398364"/>
                  </a:ext>
                </a:extLst>
              </a:tr>
            </a:tbl>
          </a:graphicData>
        </a:graphic>
      </p:graphicFrame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1E779114-E423-099E-2C29-E1440780EF6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73238335"/>
              </p:ext>
            </p:extLst>
          </p:nvPr>
        </p:nvGraphicFramePr>
        <p:xfrm>
          <a:off x="1815820" y="3092291"/>
          <a:ext cx="2920128" cy="4646295"/>
        </p:xfrm>
        <a:graphic>
          <a:graphicData uri="http://schemas.openxmlformats.org/drawingml/2006/table">
            <a:tbl>
              <a:tblPr/>
              <a:tblGrid>
                <a:gridCol w="973376">
                  <a:extLst>
                    <a:ext uri="{9D8B030D-6E8A-4147-A177-3AD203B41FA5}">
                      <a16:colId xmlns:a16="http://schemas.microsoft.com/office/drawing/2014/main" val="3155161632"/>
                    </a:ext>
                  </a:extLst>
                </a:gridCol>
                <a:gridCol w="973376">
                  <a:extLst>
                    <a:ext uri="{9D8B030D-6E8A-4147-A177-3AD203B41FA5}">
                      <a16:colId xmlns:a16="http://schemas.microsoft.com/office/drawing/2014/main" val="2989440048"/>
                    </a:ext>
                  </a:extLst>
                </a:gridCol>
                <a:gridCol w="973376">
                  <a:extLst>
                    <a:ext uri="{9D8B030D-6E8A-4147-A177-3AD203B41FA5}">
                      <a16:colId xmlns:a16="http://schemas.microsoft.com/office/drawing/2014/main" val="882217478"/>
                    </a:ext>
                  </a:extLst>
                </a:gridCol>
              </a:tblGrid>
              <a:tr h="990600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ble S8.</a:t>
                      </a:r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Pairwise </a:t>
                      </a:r>
                      <a:r>
                        <a:rPr lang="en-GB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menyi</a:t>
                      </a:r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post-hoc tests of LCBD values between habitat type within each river. Significant (p&lt;0.05) results are in bold. Note Mill Stream not presented as overall model was not statistically significant.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8664365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om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nd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il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458513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ave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066122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n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9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446680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907923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dde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nd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il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050906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ave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6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283416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n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739021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892652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ttle Stou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nd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il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791453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ave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1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102079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n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628958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8495077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ool Strea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nd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il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7005235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ave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3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2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1868914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n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942091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313120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l dat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nd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il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764667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ave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96056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n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5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4372649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1987344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with many colored dots&#10;&#10;Description automatically generated with medium confidence">
            <a:extLst>
              <a:ext uri="{FF2B5EF4-FFF2-40B4-BE49-F238E27FC236}">
                <a16:creationId xmlns:a16="http://schemas.microsoft.com/office/drawing/2014/main" id="{0E0C9821-3F51-3345-8256-BEFDA518155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9248" y="3750197"/>
            <a:ext cx="4501219" cy="450121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91D6BD8-F523-F572-7762-12C4880FAA93}"/>
              </a:ext>
            </a:extLst>
          </p:cNvPr>
          <p:cNvSpPr txBox="1"/>
          <p:nvPr/>
        </p:nvSpPr>
        <p:spPr>
          <a:xfrm>
            <a:off x="170726" y="8251416"/>
            <a:ext cx="651654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Non-metric multidimensional scaling (NMDS) of </a:t>
            </a:r>
            <a:r>
              <a:rPr lang="en-GB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acroinvertebrate community composition associated with the five UK rivers employed in the study for a) taxonomic communities and b) functional communities. </a:t>
            </a:r>
            <a:endParaRPr lang="en-GB" sz="1200" dirty="0">
              <a:highlight>
                <a:srgbClr val="FFFF00"/>
              </a:highlight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11" descr="A diagram of different colored circles&#10;&#10;Description automatically generated">
            <a:extLst>
              <a:ext uri="{FF2B5EF4-FFF2-40B4-BE49-F238E27FC236}">
                <a16:creationId xmlns:a16="http://schemas.microsoft.com/office/drawing/2014/main" id="{C8C35935-67E0-A2E1-96BD-C64041194A0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690"/>
          <a:stretch/>
        </p:blipFill>
        <p:spPr>
          <a:xfrm>
            <a:off x="1057274" y="9426"/>
            <a:ext cx="4513193" cy="41209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238422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A graph of a number of different sizes&#10;&#10;Description automatically generated with medium confidence">
            <a:extLst>
              <a:ext uri="{FF2B5EF4-FFF2-40B4-BE49-F238E27FC236}">
                <a16:creationId xmlns:a16="http://schemas.microsoft.com/office/drawing/2014/main" id="{A192E1F9-3CE5-CEA3-0587-50A9FD38F00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396"/>
          <a:stretch/>
        </p:blipFill>
        <p:spPr>
          <a:xfrm>
            <a:off x="3256618" y="283953"/>
            <a:ext cx="3335301" cy="3055254"/>
          </a:xfrm>
          <a:prstGeom prst="rect">
            <a:avLst/>
          </a:prstGeom>
        </p:spPr>
      </p:pic>
      <p:pic>
        <p:nvPicPr>
          <p:cNvPr id="13" name="Picture 12" descr="A graph of a number of boxes&#10;&#10;Description automatically generated with medium confidence">
            <a:extLst>
              <a:ext uri="{FF2B5EF4-FFF2-40B4-BE49-F238E27FC236}">
                <a16:creationId xmlns:a16="http://schemas.microsoft.com/office/drawing/2014/main" id="{62B54A42-2CA6-46D8-F925-691982A98A8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601"/>
          <a:stretch/>
        </p:blipFill>
        <p:spPr>
          <a:xfrm>
            <a:off x="109914" y="382260"/>
            <a:ext cx="3319086" cy="2934031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3C16E1FB-2367-DC8D-C2B0-FECE3B58AEEC}"/>
              </a:ext>
            </a:extLst>
          </p:cNvPr>
          <p:cNvSpPr txBox="1"/>
          <p:nvPr/>
        </p:nvSpPr>
        <p:spPr>
          <a:xfrm>
            <a:off x="308565" y="6182725"/>
            <a:ext cx="651654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edian distance to centroid values recorded a</a:t>
            </a:r>
            <a:r>
              <a:rPr lang="en-GB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habitat (all data) and b) 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ream </a:t>
            </a:r>
            <a:r>
              <a:rPr lang="en-GB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or taxonomic macroinvertebrate community composition and by c) habitat (all data) and d) 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ream </a:t>
            </a:r>
            <a:r>
              <a:rPr lang="en-GB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or functional macroinvertebrate community composition. 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oxes  show the 25</a:t>
            </a:r>
            <a:r>
              <a:rPr lang="en-GB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50</a:t>
            </a:r>
            <a:r>
              <a:rPr lang="en-GB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75</a:t>
            </a:r>
            <a:r>
              <a:rPr lang="en-GB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ercentiles, whiskers the 5</a:t>
            </a:r>
            <a:r>
              <a:rPr lang="en-GB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95</a:t>
            </a:r>
            <a:r>
              <a:rPr lang="en-GB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ercentiles.</a:t>
            </a:r>
            <a:r>
              <a:rPr lang="en-GB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FAE27B1-8271-8165-AB6E-D4EB2BE9CD87}"/>
              </a:ext>
            </a:extLst>
          </p:cNvPr>
          <p:cNvSpPr txBox="1"/>
          <p:nvPr/>
        </p:nvSpPr>
        <p:spPr>
          <a:xfrm>
            <a:off x="3765681" y="512976"/>
            <a:ext cx="19964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b)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4E5C604-0401-A257-3287-14A0568379D2}"/>
              </a:ext>
            </a:extLst>
          </p:cNvPr>
          <p:cNvSpPr txBox="1"/>
          <p:nvPr/>
        </p:nvSpPr>
        <p:spPr>
          <a:xfrm>
            <a:off x="586547" y="455491"/>
            <a:ext cx="19964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a) </a:t>
            </a:r>
          </a:p>
        </p:txBody>
      </p:sp>
      <p:pic>
        <p:nvPicPr>
          <p:cNvPr id="25" name="Picture 24" descr="A graph of a number of boxes&#10;&#10;Description automatically generated with medium confidence">
            <a:extLst>
              <a:ext uri="{FF2B5EF4-FFF2-40B4-BE49-F238E27FC236}">
                <a16:creationId xmlns:a16="http://schemas.microsoft.com/office/drawing/2014/main" id="{04FEADBF-BD50-A8AF-6C11-99F38168315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929"/>
          <a:stretch/>
        </p:blipFill>
        <p:spPr>
          <a:xfrm>
            <a:off x="3292155" y="3056211"/>
            <a:ext cx="3395119" cy="305803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519A097-0562-C918-B8B4-0E4D1D6F4F82}"/>
              </a:ext>
            </a:extLst>
          </p:cNvPr>
          <p:cNvSpPr txBox="1"/>
          <p:nvPr/>
        </p:nvSpPr>
        <p:spPr>
          <a:xfrm>
            <a:off x="3765681" y="3211203"/>
            <a:ext cx="19964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d) </a:t>
            </a:r>
          </a:p>
        </p:txBody>
      </p:sp>
      <p:pic>
        <p:nvPicPr>
          <p:cNvPr id="27" name="Picture 26" descr="A graph of a diagram&#10;&#10;Description automatically generated with medium confidence">
            <a:extLst>
              <a:ext uri="{FF2B5EF4-FFF2-40B4-BE49-F238E27FC236}">
                <a16:creationId xmlns:a16="http://schemas.microsoft.com/office/drawing/2014/main" id="{49144443-63B1-9FB3-CD71-8F56A3027A4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332"/>
          <a:stretch/>
        </p:blipFill>
        <p:spPr>
          <a:xfrm>
            <a:off x="77302" y="3083523"/>
            <a:ext cx="3387235" cy="300340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A1EAA1C-6E4D-1963-8CBD-12FEB464A64E}"/>
              </a:ext>
            </a:extLst>
          </p:cNvPr>
          <p:cNvSpPr txBox="1"/>
          <p:nvPr/>
        </p:nvSpPr>
        <p:spPr>
          <a:xfrm>
            <a:off x="584912" y="3193180"/>
            <a:ext cx="19964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c) </a:t>
            </a:r>
          </a:p>
        </p:txBody>
      </p:sp>
    </p:spTree>
    <p:extLst>
      <p:ext uri="{BB962C8B-B14F-4D97-AF65-F5344CB8AC3E}">
        <p14:creationId xmlns:p14="http://schemas.microsoft.com/office/powerpoint/2010/main" val="9395827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071</TotalTime>
  <Words>1546</Words>
  <Application>Microsoft Office PowerPoint</Application>
  <PresentationFormat>On-screen Show (4:3)</PresentationFormat>
  <Paragraphs>850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Aptos Narrow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e Mathers</dc:creator>
  <cp:lastModifiedBy>Kate Mathers</cp:lastModifiedBy>
  <cp:revision>122</cp:revision>
  <dcterms:created xsi:type="dcterms:W3CDTF">2021-12-08T12:13:45Z</dcterms:created>
  <dcterms:modified xsi:type="dcterms:W3CDTF">2024-04-30T12:15:52Z</dcterms:modified>
</cp:coreProperties>
</file>